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78467"/>
  </p:normalViewPr>
  <p:slideViewPr>
    <p:cSldViewPr snapToGrid="0" snapToObjects="1">
      <p:cViewPr varScale="1">
        <p:scale>
          <a:sx n="49" d="100"/>
          <a:sy n="49" d="100"/>
        </p:scale>
        <p:origin x="1312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5719FDA-9D4A-C84F-AEB2-72B8C68B15D4}" type="datetimeFigureOut">
              <a:rPr lang="it-IT" smtClean="0"/>
              <a:t>09/02/2022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473695E-A7F8-9940-9734-E5B821462D1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709943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b="1" dirty="0"/>
              <a:t>Fig.1 Flow Chart of the study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/>
              <a:t>Abbreviations</a:t>
            </a:r>
            <a:r>
              <a:rPr lang="en-US" sz="1200" dirty="0"/>
              <a:t>: </a:t>
            </a:r>
            <a:r>
              <a:rPr lang="en-US" sz="1200" b="1" dirty="0"/>
              <a:t>BMS</a:t>
            </a:r>
            <a:r>
              <a:rPr lang="en-US" sz="1200" dirty="0"/>
              <a:t>: burning mouth syndrome; </a:t>
            </a:r>
            <a:r>
              <a:rPr lang="en-US" sz="1200" b="1" dirty="0"/>
              <a:t>BDI</a:t>
            </a:r>
            <a:r>
              <a:rPr lang="en-US" sz="1200" b="0" dirty="0"/>
              <a:t>: Beck’s Depression Inventory</a:t>
            </a:r>
            <a:r>
              <a:rPr lang="en-US" sz="1200" dirty="0"/>
              <a:t>; </a:t>
            </a:r>
            <a:r>
              <a:rPr lang="en-US" sz="1200" b="1" dirty="0"/>
              <a:t>STAI</a:t>
            </a:r>
            <a:r>
              <a:rPr lang="en-US" sz="1200" b="0" dirty="0"/>
              <a:t>: State-Trait Anxiety Inventory;</a:t>
            </a:r>
            <a:r>
              <a:rPr lang="en-US" sz="1200" b="1" dirty="0"/>
              <a:t> VAS</a:t>
            </a:r>
            <a:r>
              <a:rPr lang="en-US" sz="1200" dirty="0"/>
              <a:t>: visual analogue scale </a:t>
            </a:r>
            <a:r>
              <a:rPr lang="en-US" sz="1200" b="1" dirty="0"/>
              <a:t>SF-MPQ</a:t>
            </a:r>
            <a:r>
              <a:rPr lang="en-US" sz="1200"/>
              <a:t>: Short-form McGill Pain Questionnaire</a:t>
            </a:r>
            <a:r>
              <a:rPr lang="it-IT" sz="1200"/>
              <a:t>; </a:t>
            </a:r>
            <a:r>
              <a:rPr lang="it-IT" sz="1200" b="1" dirty="0"/>
              <a:t>PD-Q: </a:t>
            </a:r>
            <a:r>
              <a:rPr lang="it-IT" sz="1200" dirty="0" err="1"/>
              <a:t>PainDETECT</a:t>
            </a:r>
            <a:r>
              <a:rPr lang="it-IT" sz="1200" dirty="0"/>
              <a:t> </a:t>
            </a:r>
            <a:r>
              <a:rPr lang="it-IT" sz="1200" dirty="0" err="1"/>
              <a:t>Questionnaire</a:t>
            </a:r>
            <a:r>
              <a:rPr lang="it-IT" sz="1200" dirty="0"/>
              <a:t>; </a:t>
            </a:r>
            <a:r>
              <a:rPr lang="it-IT" sz="1200" b="1" dirty="0"/>
              <a:t>BPI: </a:t>
            </a:r>
            <a:r>
              <a:rPr lang="it-IT" sz="1200" dirty="0"/>
              <a:t>Brief </a:t>
            </a:r>
            <a:r>
              <a:rPr lang="it-IT" sz="1200" dirty="0" err="1"/>
              <a:t>Pain</a:t>
            </a:r>
            <a:r>
              <a:rPr lang="it-IT" sz="1200" dirty="0"/>
              <a:t> </a:t>
            </a:r>
            <a:r>
              <a:rPr lang="it-IT" sz="1200" dirty="0" err="1"/>
              <a:t>Intensity</a:t>
            </a:r>
            <a:r>
              <a:rPr lang="it-IT" sz="1200" dirty="0"/>
              <a:t>;</a:t>
            </a:r>
            <a:r>
              <a:rPr lang="en-US" sz="1200" b="0" dirty="0"/>
              <a:t> </a:t>
            </a:r>
            <a:r>
              <a:rPr lang="en-US" sz="1200" b="1" dirty="0"/>
              <a:t>PSQI</a:t>
            </a:r>
            <a:r>
              <a:rPr lang="en-US" sz="1200" dirty="0"/>
              <a:t>: Pittsburgh Sleep Quality Index; </a:t>
            </a:r>
            <a:r>
              <a:rPr lang="en-US" sz="1200" b="1" dirty="0"/>
              <a:t>ESS</a:t>
            </a:r>
            <a:r>
              <a:rPr lang="en-US" sz="1200" dirty="0"/>
              <a:t>: Epworth Sleepiness Scale</a:t>
            </a:r>
            <a:r>
              <a:rPr lang="it-IT" sz="1200" dirty="0"/>
              <a:t>;</a:t>
            </a:r>
            <a:r>
              <a:rPr lang="en-US" sz="1200" dirty="0"/>
              <a:t>; </a:t>
            </a:r>
            <a:r>
              <a:rPr lang="it-IT" sz="1200" dirty="0"/>
              <a:t>Inventory; </a:t>
            </a:r>
            <a:r>
              <a:rPr lang="it-IT" sz="1200" b="1" dirty="0"/>
              <a:t>SF-36: </a:t>
            </a:r>
            <a:r>
              <a:rPr lang="it-IT" sz="1200" dirty="0"/>
              <a:t>36 items Short Form Survey; </a:t>
            </a:r>
            <a:r>
              <a:rPr lang="it-IT" sz="1200" b="1" dirty="0"/>
              <a:t>OHIP-14</a:t>
            </a:r>
            <a:r>
              <a:rPr lang="it-IT" sz="1200" b="0" dirty="0"/>
              <a:t>: </a:t>
            </a:r>
            <a:r>
              <a:rPr lang="it-IT" sz="1200" b="0" dirty="0" err="1"/>
              <a:t>Oral</a:t>
            </a:r>
            <a:r>
              <a:rPr lang="it-IT" sz="1200" b="0" dirty="0"/>
              <a:t> Health Impact </a:t>
            </a:r>
            <a:r>
              <a:rPr lang="it-IT" sz="1200" b="0" dirty="0" err="1"/>
              <a:t>Profile</a:t>
            </a:r>
            <a:r>
              <a:rPr lang="it-IT" sz="1200" b="0" dirty="0"/>
              <a:t>.</a:t>
            </a:r>
            <a:endParaRPr lang="en-US" sz="1200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2DCB8BF-A92E-AA42-B694-B7523528ECF0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784068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53982AD-96CD-684F-A538-4A03DED01BB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CB32729E-D367-EC4F-A8E1-30BEEB874AE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0422B55-5DEC-9A4A-904B-30341FBF5F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5C030-0380-4847-8F06-C3C11DBC2161}" type="datetimeFigureOut">
              <a:rPr lang="it-IT" smtClean="0"/>
              <a:t>09/02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67BBF48-F03E-3A4D-B5C7-F0BC9EBB55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8F57C82-C7F3-8442-B3EE-93DAAA3EB8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93CD4B-FF8A-DF4B-9F79-F1682D543A3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739910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5BFB085-E80C-CB47-B192-60E290E8A7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FD3123E3-546A-0849-8534-8CFD33E6E4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7AC2969-9E34-ED41-922C-5EC70E2C48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5C030-0380-4847-8F06-C3C11DBC2161}" type="datetimeFigureOut">
              <a:rPr lang="it-IT" smtClean="0"/>
              <a:t>09/02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47BA5BA-9773-AC4D-AD16-3178D82653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60CF3F1-0CBE-2F4F-AA88-74075C75D9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93CD4B-FF8A-DF4B-9F79-F1682D543A3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679662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C66833B7-4FE9-DB4E-BBEB-37456A7A93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012549BD-2ECF-AF47-8C50-2C4171D04B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C8B4EC4-C915-B440-99D7-1EDC29E5A2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5C030-0380-4847-8F06-C3C11DBC2161}" type="datetimeFigureOut">
              <a:rPr lang="it-IT" smtClean="0"/>
              <a:t>09/02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E1A5E9B-AD00-464F-9619-DF85361525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7F63511-8BCF-B34D-BFBF-8A124E324F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93CD4B-FF8A-DF4B-9F79-F1682D543A3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065231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D929B40-6E79-4044-9BF1-3CEA277089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416D05C-EB14-734B-9BC7-7E06BFC4DA6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6D22628-CC65-0542-8417-988444E34A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5C030-0380-4847-8F06-C3C11DBC2161}" type="datetimeFigureOut">
              <a:rPr lang="it-IT" smtClean="0"/>
              <a:t>09/02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22575BC-8A31-2449-B14A-8637CD3E14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0F21AD0-2960-2842-99F9-71BFF24005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93CD4B-FF8A-DF4B-9F79-F1682D543A3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959373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4A69E4C-D295-F841-8ED9-7A0D26F829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900F4F2-7D40-7B4A-81B6-E17BBCE84E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FD56BBF-D744-D643-BD05-850019E88D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5C030-0380-4847-8F06-C3C11DBC2161}" type="datetimeFigureOut">
              <a:rPr lang="it-IT" smtClean="0"/>
              <a:t>09/02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FE56116-053E-464B-8F77-A3B971E14E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10F1282-7071-524A-80F9-69417E86E0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93CD4B-FF8A-DF4B-9F79-F1682D543A3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030568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6DD8EC8-4B27-CB41-978A-E480DC9D08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FE6A50A2-9C26-654B-A4A1-7BDCD03B345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8256FCFB-9C1E-3A4A-848B-34BA2529240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ED5B5CA0-F3BF-BB46-98C6-41ACA8D1C6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5C030-0380-4847-8F06-C3C11DBC2161}" type="datetimeFigureOut">
              <a:rPr lang="it-IT" smtClean="0"/>
              <a:t>09/02/20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F645417-6412-A446-8BC8-BFA8865C76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EE2620D2-1137-5948-8ADF-7CAFC43A04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93CD4B-FF8A-DF4B-9F79-F1682D543A3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9182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AD55C24-5A31-AF4E-A09D-C036EEE7F6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98D1E171-04FB-6F45-A03C-2C13949F2F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201BAA8-0E95-544F-90E1-038B9F8DBF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D7E63EB4-7E29-AC4B-B2EB-FFFD3015202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FF32C214-74E7-544F-BB2A-F802AFB8D8D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720BAEEE-48EC-B04C-875F-5A10FCEA78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5C030-0380-4847-8F06-C3C11DBC2161}" type="datetimeFigureOut">
              <a:rPr lang="it-IT" smtClean="0"/>
              <a:t>09/02/2022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3A6C6E90-BC40-D74B-8DA6-90FBB052D8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E2900B47-E46B-F84F-9CE9-77A91E6008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93CD4B-FF8A-DF4B-9F79-F1682D543A3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499593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7EC6F14-DAF9-8748-B3E8-6D048F3750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3D074C31-69A2-0D44-84F1-39B3CA46E4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5C030-0380-4847-8F06-C3C11DBC2161}" type="datetimeFigureOut">
              <a:rPr lang="it-IT" smtClean="0"/>
              <a:t>09/02/2022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AE7225AF-FCDC-4F4E-A32D-74A3CF0360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6D01DC3A-EA7F-4245-8465-BFAFA1D988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93CD4B-FF8A-DF4B-9F79-F1682D543A3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580902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9C9FB5EA-185B-2D4F-9E36-21F4BACA02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5C030-0380-4847-8F06-C3C11DBC2161}" type="datetimeFigureOut">
              <a:rPr lang="it-IT" smtClean="0"/>
              <a:t>09/02/2022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033E8E34-CFD0-6340-9BA1-AAAB742321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44359FBD-5C78-EF4A-9C94-48B0D359DA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93CD4B-FF8A-DF4B-9F79-F1682D543A3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28694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B4E785F-B166-0048-88F1-88F6805CE7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E8A4A950-F998-CE47-BF37-7897627189F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24CC6E9C-7A28-A041-86F7-D31D56A3B7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92F87FA-BA2A-F241-B446-190D4033A0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5C030-0380-4847-8F06-C3C11DBC2161}" type="datetimeFigureOut">
              <a:rPr lang="it-IT" smtClean="0"/>
              <a:t>09/02/20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C3F1318-D638-2445-A9D4-52720E7631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7870FF7C-FC16-4F42-BC45-9E19A2348E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93CD4B-FF8A-DF4B-9F79-F1682D543A3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95581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04E361A-2A92-D843-B8F2-7049CD7833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55AF7435-3B7B-D94B-B9CF-DF8E83E6ECE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EC8ED6B9-B671-AE4B-9530-C35CAB5B72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D017762-2A1C-2D4A-A568-38E533A35D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5C030-0380-4847-8F06-C3C11DBC2161}" type="datetimeFigureOut">
              <a:rPr lang="it-IT" smtClean="0"/>
              <a:t>09/02/20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C504AC93-1F3D-3A43-9EDE-89B3A48033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4736C1E-7581-924B-9DDA-8D19759714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93CD4B-FF8A-DF4B-9F79-F1682D543A3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105383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7215A766-56CD-574A-975C-1E340FE65C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09A0CD89-28E7-5747-B707-5515F7E995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366E3D2-6608-7B49-A619-961832426D1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75C030-0380-4847-8F06-C3C11DBC2161}" type="datetimeFigureOut">
              <a:rPr lang="it-IT" smtClean="0"/>
              <a:t>09/02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0A115E9-A3CE-B04A-A198-B1A1E811A04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ABC5CAE-5AF0-0C44-A19C-D93321A6DC1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93CD4B-FF8A-DF4B-9F79-F1682D543A3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512903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 di testo 3">
            <a:extLst>
              <a:ext uri="{FF2B5EF4-FFF2-40B4-BE49-F238E27FC236}">
                <a16:creationId xmlns:a16="http://schemas.microsoft.com/office/drawing/2014/main" id="{2573F621-34C8-D44C-9807-C677419A1C41}"/>
              </a:ext>
            </a:extLst>
          </p:cNvPr>
          <p:cNvSpPr txBox="1"/>
          <p:nvPr/>
        </p:nvSpPr>
        <p:spPr>
          <a:xfrm>
            <a:off x="2299107" y="1870548"/>
            <a:ext cx="2147416" cy="640381"/>
          </a:xfrm>
          <a:prstGeom prst="rect">
            <a:avLst/>
          </a:prstGeom>
          <a:noFill/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MS patients assessed for eligibility</a:t>
            </a:r>
          </a:p>
          <a:p>
            <a:pPr algn="ctr"/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 N= 46)</a:t>
            </a:r>
            <a:endParaRPr lang="it-IT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6" name="Connettore 2 5">
            <a:extLst>
              <a:ext uri="{FF2B5EF4-FFF2-40B4-BE49-F238E27FC236}">
                <a16:creationId xmlns:a16="http://schemas.microsoft.com/office/drawing/2014/main" id="{85FE8108-C723-6847-99F2-BBFE1B6119FE}"/>
              </a:ext>
            </a:extLst>
          </p:cNvPr>
          <p:cNvCxnSpPr>
            <a:cxnSpLocks/>
          </p:cNvCxnSpPr>
          <p:nvPr/>
        </p:nvCxnSpPr>
        <p:spPr>
          <a:xfrm>
            <a:off x="3252805" y="2507337"/>
            <a:ext cx="0" cy="138243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3699BF61-BDAA-7E4C-9AA3-0CF2434E3476}"/>
              </a:ext>
            </a:extLst>
          </p:cNvPr>
          <p:cNvSpPr txBox="1"/>
          <p:nvPr/>
        </p:nvSpPr>
        <p:spPr>
          <a:xfrm>
            <a:off x="334140" y="476262"/>
            <a:ext cx="1524642" cy="369332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it-IT"/>
              <a:t>Recruitment</a:t>
            </a:r>
            <a:r>
              <a:rPr lang="it-IT" dirty="0"/>
              <a:t> </a:t>
            </a:r>
          </a:p>
        </p:txBody>
      </p:sp>
      <p:cxnSp>
        <p:nvCxnSpPr>
          <p:cNvPr id="10" name="Connettore 2 9">
            <a:extLst>
              <a:ext uri="{FF2B5EF4-FFF2-40B4-BE49-F238E27FC236}">
                <a16:creationId xmlns:a16="http://schemas.microsoft.com/office/drawing/2014/main" id="{A53E93CA-FA53-684B-8DB7-F8E99C2420D6}"/>
              </a:ext>
            </a:extLst>
          </p:cNvPr>
          <p:cNvCxnSpPr>
            <a:cxnSpLocks/>
          </p:cNvCxnSpPr>
          <p:nvPr/>
        </p:nvCxnSpPr>
        <p:spPr>
          <a:xfrm>
            <a:off x="3275795" y="3036208"/>
            <a:ext cx="652093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Casella di testo 3">
            <a:extLst>
              <a:ext uri="{FF2B5EF4-FFF2-40B4-BE49-F238E27FC236}">
                <a16:creationId xmlns:a16="http://schemas.microsoft.com/office/drawing/2014/main" id="{F61EA88B-489E-A249-9688-344C4045D214}"/>
              </a:ext>
            </a:extLst>
          </p:cNvPr>
          <p:cNvSpPr txBox="1"/>
          <p:nvPr/>
        </p:nvSpPr>
        <p:spPr>
          <a:xfrm>
            <a:off x="9889323" y="2378116"/>
            <a:ext cx="2185619" cy="1511656"/>
          </a:xfrm>
          <a:prstGeom prst="rect">
            <a:avLst/>
          </a:prstGeom>
          <a:noFill/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MS patients  and Healthy subjects excluded for reason (n=10)</a:t>
            </a:r>
          </a:p>
          <a:p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Not meeting inclusion/ exclusion criteria</a:t>
            </a:r>
          </a:p>
          <a:p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No consent to </a:t>
            </a:r>
            <a:r>
              <a:rPr lang="en-US" sz="12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rticipate in th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udy</a:t>
            </a:r>
          </a:p>
          <a:p>
            <a:pPr algn="ctr"/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/>
            <a:endParaRPr lang="it-IT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3" name="Casella di testo 3">
            <a:extLst>
              <a:ext uri="{FF2B5EF4-FFF2-40B4-BE49-F238E27FC236}">
                <a16:creationId xmlns:a16="http://schemas.microsoft.com/office/drawing/2014/main" id="{0F054A5E-1740-0344-B00C-36AEC26AF834}"/>
              </a:ext>
            </a:extLst>
          </p:cNvPr>
          <p:cNvSpPr txBox="1"/>
          <p:nvPr/>
        </p:nvSpPr>
        <p:spPr>
          <a:xfrm>
            <a:off x="2191618" y="3889772"/>
            <a:ext cx="2630762" cy="636789"/>
          </a:xfrm>
          <a:prstGeom prst="rect">
            <a:avLst/>
          </a:prstGeom>
          <a:noFill/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BMS patients included in the study</a:t>
            </a:r>
          </a:p>
          <a:p>
            <a:pPr algn="ctr"/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N=40)</a:t>
            </a:r>
          </a:p>
          <a:p>
            <a:pPr algn="ctr"/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0 female/10male</a:t>
            </a:r>
          </a:p>
          <a:p>
            <a:pPr algn="ctr"/>
            <a:endParaRPr lang="it-IT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824CB0BD-8E2D-E24B-A7E1-534F22ECC1D2}"/>
              </a:ext>
            </a:extLst>
          </p:cNvPr>
          <p:cNvSpPr txBox="1"/>
          <p:nvPr/>
        </p:nvSpPr>
        <p:spPr>
          <a:xfrm>
            <a:off x="273730" y="1906813"/>
            <a:ext cx="1197519" cy="369332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it-IT" dirty="0" err="1"/>
              <a:t>Eligibility</a:t>
            </a:r>
            <a:endParaRPr lang="it-IT" dirty="0"/>
          </a:p>
        </p:txBody>
      </p:sp>
      <p:sp>
        <p:nvSpPr>
          <p:cNvPr id="74" name="CasellaDiTesto 73">
            <a:extLst>
              <a:ext uri="{FF2B5EF4-FFF2-40B4-BE49-F238E27FC236}">
                <a16:creationId xmlns:a16="http://schemas.microsoft.com/office/drawing/2014/main" id="{D19A8BE1-DBBC-2542-9B07-D17CABFA30A7}"/>
              </a:ext>
            </a:extLst>
          </p:cNvPr>
          <p:cNvSpPr txBox="1"/>
          <p:nvPr/>
        </p:nvSpPr>
        <p:spPr>
          <a:xfrm>
            <a:off x="338988" y="5812591"/>
            <a:ext cx="1132261" cy="369332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it-IT" dirty="0"/>
              <a:t>Analysis </a:t>
            </a:r>
          </a:p>
        </p:txBody>
      </p:sp>
      <p:sp>
        <p:nvSpPr>
          <p:cNvPr id="50" name="Casella di testo 3">
            <a:extLst>
              <a:ext uri="{FF2B5EF4-FFF2-40B4-BE49-F238E27FC236}">
                <a16:creationId xmlns:a16="http://schemas.microsoft.com/office/drawing/2014/main" id="{0EC5FAF0-43ED-CF44-9817-853623F5D11A}"/>
              </a:ext>
            </a:extLst>
          </p:cNvPr>
          <p:cNvSpPr txBox="1"/>
          <p:nvPr/>
        </p:nvSpPr>
        <p:spPr>
          <a:xfrm>
            <a:off x="7553668" y="1857463"/>
            <a:ext cx="2158756" cy="670387"/>
          </a:xfrm>
          <a:prstGeom prst="rect">
            <a:avLst/>
          </a:prstGeom>
          <a:noFill/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ealthy subjects</a:t>
            </a:r>
          </a:p>
          <a:p>
            <a:pPr algn="ctr"/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sessed for eligibility </a:t>
            </a:r>
          </a:p>
          <a:p>
            <a:pPr algn="ctr"/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 N= 44)</a:t>
            </a:r>
            <a:endParaRPr lang="it-IT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8" name="Casella di testo 3">
            <a:extLst>
              <a:ext uri="{FF2B5EF4-FFF2-40B4-BE49-F238E27FC236}">
                <a16:creationId xmlns:a16="http://schemas.microsoft.com/office/drawing/2014/main" id="{5C31D419-E46A-F147-B68F-55F4CB7E25E6}"/>
              </a:ext>
            </a:extLst>
          </p:cNvPr>
          <p:cNvSpPr txBox="1"/>
          <p:nvPr/>
        </p:nvSpPr>
        <p:spPr>
          <a:xfrm>
            <a:off x="6776357" y="3931196"/>
            <a:ext cx="2859034" cy="612042"/>
          </a:xfrm>
          <a:prstGeom prst="rect">
            <a:avLst/>
          </a:prstGeom>
          <a:noFill/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Healthy subjects included in the study </a:t>
            </a:r>
          </a:p>
          <a:p>
            <a:pPr algn="ctr"/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N=40)</a:t>
            </a:r>
          </a:p>
          <a:p>
            <a:pPr algn="ctr"/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9 female/11 male</a:t>
            </a:r>
            <a:endParaRPr lang="it-IT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60" name="Connettore 2 59">
            <a:extLst>
              <a:ext uri="{FF2B5EF4-FFF2-40B4-BE49-F238E27FC236}">
                <a16:creationId xmlns:a16="http://schemas.microsoft.com/office/drawing/2014/main" id="{40C83C1F-30DB-6540-87C0-DC7632A92B00}"/>
              </a:ext>
            </a:extLst>
          </p:cNvPr>
          <p:cNvCxnSpPr>
            <a:cxnSpLocks/>
          </p:cNvCxnSpPr>
          <p:nvPr/>
        </p:nvCxnSpPr>
        <p:spPr>
          <a:xfrm>
            <a:off x="8633046" y="2510929"/>
            <a:ext cx="0" cy="137884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Casella di testo 3">
            <a:extLst>
              <a:ext uri="{FF2B5EF4-FFF2-40B4-BE49-F238E27FC236}">
                <a16:creationId xmlns:a16="http://schemas.microsoft.com/office/drawing/2014/main" id="{FADFA75F-1A89-9D49-937D-2FB5F6374D03}"/>
              </a:ext>
            </a:extLst>
          </p:cNvPr>
          <p:cNvSpPr txBox="1"/>
          <p:nvPr/>
        </p:nvSpPr>
        <p:spPr>
          <a:xfrm>
            <a:off x="4822380" y="350134"/>
            <a:ext cx="2147416" cy="640381"/>
          </a:xfrm>
          <a:prstGeom prst="rect">
            <a:avLst/>
          </a:prstGeom>
          <a:noFill/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ubjects recruited </a:t>
            </a:r>
          </a:p>
          <a:p>
            <a:pPr algn="ctr"/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 N= 90)</a:t>
            </a:r>
            <a:endParaRPr lang="it-IT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64" name="Connettore 2 63">
            <a:extLst>
              <a:ext uri="{FF2B5EF4-FFF2-40B4-BE49-F238E27FC236}">
                <a16:creationId xmlns:a16="http://schemas.microsoft.com/office/drawing/2014/main" id="{DC69593F-924D-4B4F-A091-83AA7C43F3F1}"/>
              </a:ext>
            </a:extLst>
          </p:cNvPr>
          <p:cNvCxnSpPr>
            <a:cxnSpLocks/>
          </p:cNvCxnSpPr>
          <p:nvPr/>
        </p:nvCxnSpPr>
        <p:spPr>
          <a:xfrm flipH="1">
            <a:off x="3808071" y="1012210"/>
            <a:ext cx="1950797" cy="72156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Connettore 2 77">
            <a:extLst>
              <a:ext uri="{FF2B5EF4-FFF2-40B4-BE49-F238E27FC236}">
                <a16:creationId xmlns:a16="http://schemas.microsoft.com/office/drawing/2014/main" id="{DF69EB15-7750-6042-9F8C-25196486FDB1}"/>
              </a:ext>
            </a:extLst>
          </p:cNvPr>
          <p:cNvCxnSpPr>
            <a:cxnSpLocks/>
          </p:cNvCxnSpPr>
          <p:nvPr/>
        </p:nvCxnSpPr>
        <p:spPr>
          <a:xfrm>
            <a:off x="5766563" y="1006465"/>
            <a:ext cx="2185245" cy="79096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Connettore 2 78">
            <a:extLst>
              <a:ext uri="{FF2B5EF4-FFF2-40B4-BE49-F238E27FC236}">
                <a16:creationId xmlns:a16="http://schemas.microsoft.com/office/drawing/2014/main" id="{73D7140B-7836-484B-A52E-9A34AFC87729}"/>
              </a:ext>
            </a:extLst>
          </p:cNvPr>
          <p:cNvCxnSpPr>
            <a:cxnSpLocks/>
          </p:cNvCxnSpPr>
          <p:nvPr/>
        </p:nvCxnSpPr>
        <p:spPr>
          <a:xfrm>
            <a:off x="8633046" y="4647741"/>
            <a:ext cx="0" cy="68190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Connettore 2 81">
            <a:extLst>
              <a:ext uri="{FF2B5EF4-FFF2-40B4-BE49-F238E27FC236}">
                <a16:creationId xmlns:a16="http://schemas.microsoft.com/office/drawing/2014/main" id="{6462C6C1-D6C2-9346-8A59-F00DE46EAA99}"/>
              </a:ext>
            </a:extLst>
          </p:cNvPr>
          <p:cNvCxnSpPr>
            <a:cxnSpLocks/>
          </p:cNvCxnSpPr>
          <p:nvPr/>
        </p:nvCxnSpPr>
        <p:spPr>
          <a:xfrm>
            <a:off x="3241905" y="4647741"/>
            <a:ext cx="0" cy="68190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Casella di testo 3">
            <a:extLst>
              <a:ext uri="{FF2B5EF4-FFF2-40B4-BE49-F238E27FC236}">
                <a16:creationId xmlns:a16="http://schemas.microsoft.com/office/drawing/2014/main" id="{7B839CFB-9081-7A46-A411-796C23A798F3}"/>
              </a:ext>
            </a:extLst>
          </p:cNvPr>
          <p:cNvSpPr txBox="1"/>
          <p:nvPr/>
        </p:nvSpPr>
        <p:spPr>
          <a:xfrm>
            <a:off x="1776350" y="5421548"/>
            <a:ext cx="8112974" cy="1100019"/>
          </a:xfrm>
          <a:prstGeom prst="rect">
            <a:avLst/>
          </a:prstGeom>
          <a:noFill/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valuation of Psychological Profile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BDI, STAI </a:t>
            </a:r>
          </a:p>
          <a:p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valuation of Pain: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AS; SF-MPQ; BPI ;PD-Q</a:t>
            </a:r>
          </a:p>
          <a:p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valuation of Quality of Sleep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PSQI; ESS</a:t>
            </a:r>
          </a:p>
          <a:p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valuation of Quality of Life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 SF-36</a:t>
            </a:r>
          </a:p>
          <a:p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valuation of Oral Health: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HIP-14</a:t>
            </a:r>
          </a:p>
        </p:txBody>
      </p:sp>
    </p:spTree>
    <p:extLst>
      <p:ext uri="{BB962C8B-B14F-4D97-AF65-F5344CB8AC3E}">
        <p14:creationId xmlns:p14="http://schemas.microsoft.com/office/powerpoint/2010/main" val="207412329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37</TotalTime>
  <Words>218</Words>
  <Application>Microsoft Office PowerPoint</Application>
  <PresentationFormat>Widescreen</PresentationFormat>
  <Paragraphs>27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daniela adamo</dc:creator>
  <cp:lastModifiedBy>federica canfora</cp:lastModifiedBy>
  <cp:revision>34</cp:revision>
  <cp:lastPrinted>2020-12-08T17:22:46Z</cp:lastPrinted>
  <dcterms:created xsi:type="dcterms:W3CDTF">2020-11-17T17:08:15Z</dcterms:created>
  <dcterms:modified xsi:type="dcterms:W3CDTF">2022-02-09T11:59:12Z</dcterms:modified>
</cp:coreProperties>
</file>